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8"/>
  </p:notesMasterIdLst>
  <p:sldIdLst>
    <p:sldId id="272" r:id="rId2"/>
    <p:sldId id="273" r:id="rId3"/>
    <p:sldId id="263" r:id="rId4"/>
    <p:sldId id="264" r:id="rId5"/>
    <p:sldId id="265" r:id="rId6"/>
    <p:sldId id="268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098"/>
    <p:restoredTop sz="85600"/>
  </p:normalViewPr>
  <p:slideViewPr>
    <p:cSldViewPr snapToGrid="0">
      <p:cViewPr varScale="1">
        <p:scale>
          <a:sx n="60" d="100"/>
          <a:sy n="60" d="100"/>
        </p:scale>
        <p:origin x="40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F51016-948E-D445-8CEF-0799B8B23EB6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A5BCB0-4D62-804E-A07B-2C182551878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8832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5BCB0-4D62-804E-A07B-2C1825518789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73189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5BCB0-4D62-804E-A07B-2C1825518789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594576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5BCB0-4D62-804E-A07B-2C1825518789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2767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5BCB0-4D62-804E-A07B-2C1825518789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936133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5BCB0-4D62-804E-A07B-2C1825518789}" type="slidenum">
              <a:rPr lang="fr-FR" smtClean="0"/>
              <a:t>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247718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5BCB0-4D62-804E-A07B-2C1825518789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0243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4090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077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0133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9049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76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8497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4264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864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0856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3609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5725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FDD1E0-29F1-CF48-9606-C0C07BFAEA1C}" type="datetimeFigureOut">
              <a:rPr lang="fr-FR" smtClean="0"/>
              <a:t>12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D142A-77BD-D74D-84DE-C142ED0680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3240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BC23EE82-D06E-E689-653A-B3E2F89550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136" y="1931174"/>
            <a:ext cx="6711215" cy="350442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530DD224-7E2E-C15D-295C-ADEC3C3428AD}"/>
              </a:ext>
            </a:extLst>
          </p:cNvPr>
          <p:cNvSpPr txBox="1"/>
          <p:nvPr/>
        </p:nvSpPr>
        <p:spPr>
          <a:xfrm>
            <a:off x="93137" y="5554130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fr-FR" b="1" dirty="0">
                <a:solidFill>
                  <a:srgbClr val="000000"/>
                </a:solidFill>
                <a:latin typeface="Arial" panose="020B0604020202020204" pitchFamily="34" charset="0"/>
              </a:rPr>
              <a:t> Figure S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07432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731D49D4-E2E1-365D-D007-3617E9810D85}"/>
              </a:ext>
            </a:extLst>
          </p:cNvPr>
          <p:cNvSpPr txBox="1"/>
          <p:nvPr/>
        </p:nvSpPr>
        <p:spPr>
          <a:xfrm>
            <a:off x="0" y="9536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fr-FR" b="1" dirty="0">
                <a:solidFill>
                  <a:srgbClr val="000000"/>
                </a:solidFill>
                <a:latin typeface="Arial" panose="020B0604020202020204" pitchFamily="34" charset="0"/>
              </a:rPr>
              <a:t> Figure S2</a:t>
            </a:r>
            <a:endParaRPr lang="fr-FR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19D74DF1-ECEB-7584-C39D-0043A23E6D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4406"/>
            <a:ext cx="6858000" cy="9556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306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C77B4B2D-3FF1-7246-6CAA-B386015DEB71}"/>
              </a:ext>
            </a:extLst>
          </p:cNvPr>
          <p:cNvSpPr txBox="1"/>
          <p:nvPr/>
        </p:nvSpPr>
        <p:spPr>
          <a:xfrm>
            <a:off x="1" y="5991064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fr-FR" b="1" dirty="0">
                <a:solidFill>
                  <a:srgbClr val="000000"/>
                </a:solidFill>
                <a:latin typeface="Arial" panose="020B0604020202020204" pitchFamily="34" charset="0"/>
              </a:rPr>
              <a:t> Figure S3</a:t>
            </a:r>
            <a:endParaRPr lang="fr-FR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A2DC5579-1E43-310C-F100-016C78F38E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98625"/>
            <a:ext cx="6858000" cy="5180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56281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A2D84E0C-C405-37B7-86E5-165EE57912B8}"/>
              </a:ext>
            </a:extLst>
          </p:cNvPr>
          <p:cNvSpPr txBox="1"/>
          <p:nvPr/>
        </p:nvSpPr>
        <p:spPr>
          <a:xfrm>
            <a:off x="138225" y="5613991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fr-FR" b="1" dirty="0">
                <a:solidFill>
                  <a:srgbClr val="000000"/>
                </a:solidFill>
                <a:latin typeface="Arial" panose="020B0604020202020204" pitchFamily="34" charset="0"/>
              </a:rPr>
              <a:t> Figure S4</a:t>
            </a:r>
            <a:endParaRPr lang="fr-FR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CA3F5186-D43E-1B96-4F10-46E1E61933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39153"/>
            <a:ext cx="6858000" cy="5169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97171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8AD86AE8-33AC-D917-BE06-C520268CD354}"/>
              </a:ext>
            </a:extLst>
          </p:cNvPr>
          <p:cNvSpPr txBox="1"/>
          <p:nvPr/>
        </p:nvSpPr>
        <p:spPr>
          <a:xfrm>
            <a:off x="138225" y="6379533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fr-FR" b="1" dirty="0">
                <a:solidFill>
                  <a:srgbClr val="000000"/>
                </a:solidFill>
                <a:latin typeface="Arial" panose="020B0604020202020204" pitchFamily="34" charset="0"/>
              </a:rPr>
              <a:t> Figure S5</a:t>
            </a:r>
            <a:endParaRPr lang="fr-FR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94434B31-D0CB-05D7-6F3D-7A2FD37E9B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941793"/>
            <a:ext cx="6858000" cy="5169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44203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A7F704B4-C8A4-E4E5-3D26-D697C18843A7}"/>
              </a:ext>
            </a:extLst>
          </p:cNvPr>
          <p:cNvSpPr txBox="1"/>
          <p:nvPr/>
        </p:nvSpPr>
        <p:spPr>
          <a:xfrm>
            <a:off x="1" y="5699052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0000"/>
                </a:solidFill>
                <a:latin typeface="Arial" panose="020B0604020202020204" pitchFamily="34" charset="0"/>
              </a:rPr>
              <a:t>Supplementary</a:t>
            </a:r>
            <a:r>
              <a:rPr lang="fr-FR" b="1" dirty="0">
                <a:solidFill>
                  <a:srgbClr val="000000"/>
                </a:solidFill>
                <a:latin typeface="Arial" panose="020B0604020202020204" pitchFamily="34" charset="0"/>
              </a:rPr>
              <a:t> Figure S6</a:t>
            </a:r>
            <a:endParaRPr lang="fr-FR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D123792E-2445-6058-A597-6EA4FC77A3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529705"/>
            <a:ext cx="6858000" cy="5169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21989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4766</TotalTime>
  <Words>24</Words>
  <Application>Microsoft Macintosh PowerPoint</Application>
  <PresentationFormat>Format A4 (210 x 297 mm)</PresentationFormat>
  <Paragraphs>12</Paragraphs>
  <Slides>6</Slides>
  <Notes>6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ain Lamoine</dc:creator>
  <cp:lastModifiedBy>Lamoine Sylvain</cp:lastModifiedBy>
  <cp:revision>38</cp:revision>
  <dcterms:created xsi:type="dcterms:W3CDTF">2023-06-21T08:25:45Z</dcterms:created>
  <dcterms:modified xsi:type="dcterms:W3CDTF">2024-08-12T14:26:02Z</dcterms:modified>
</cp:coreProperties>
</file>